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4CB0BC4-BC70-43D8-845C-4547BD3870AA}" v="1" dt="2026-05-26T22:07:15.979"/>
    <p1510:client id="{D898F380-58C9-4827-B92C-28BCCED6B59F}" v="1" dt="2026-05-26T22:38:17.30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nirujjaman, Md." userId="71830597-1daa-4b00-a396-8c0b49de16a4" providerId="ADAL" clId="{11852027-B5BD-488B-81C4-BC06A6EE44F8}"/>
    <pc:docChg chg="undo custSel addSld modSld">
      <pc:chgData name="Manirujjaman, Md." userId="71830597-1daa-4b00-a396-8c0b49de16a4" providerId="ADAL" clId="{11852027-B5BD-488B-81C4-BC06A6EE44F8}" dt="2026-05-26T22:40:27.757" v="108" actId="1036"/>
      <pc:docMkLst>
        <pc:docMk/>
      </pc:docMkLst>
      <pc:sldChg chg="addSp delSp modSp new mod">
        <pc:chgData name="Manirujjaman, Md." userId="71830597-1daa-4b00-a396-8c0b49de16a4" providerId="ADAL" clId="{11852027-B5BD-488B-81C4-BC06A6EE44F8}" dt="2026-05-26T22:40:27.757" v="108" actId="1036"/>
        <pc:sldMkLst>
          <pc:docMk/>
          <pc:sldMk cId="3551134013" sldId="256"/>
        </pc:sldMkLst>
        <pc:spChg chg="del">
          <ac:chgData name="Manirujjaman, Md." userId="71830597-1daa-4b00-a396-8c0b49de16a4" providerId="ADAL" clId="{11852027-B5BD-488B-81C4-BC06A6EE44F8}" dt="2026-05-26T22:06:32.771" v="1" actId="478"/>
          <ac:spMkLst>
            <pc:docMk/>
            <pc:sldMk cId="3551134013" sldId="256"/>
            <ac:spMk id="2" creationId="{37146492-EFFF-E389-9DB1-B10EC3EBCAB2}"/>
          </ac:spMkLst>
        </pc:spChg>
        <pc:spChg chg="del">
          <ac:chgData name="Manirujjaman, Md." userId="71830597-1daa-4b00-a396-8c0b49de16a4" providerId="ADAL" clId="{11852027-B5BD-488B-81C4-BC06A6EE44F8}" dt="2026-05-26T22:06:33.701" v="2" actId="478"/>
          <ac:spMkLst>
            <pc:docMk/>
            <pc:sldMk cId="3551134013" sldId="256"/>
            <ac:spMk id="3" creationId="{0B5F8A3B-6187-F0DB-E2B2-F6C22922FC10}"/>
          </ac:spMkLst>
        </pc:spChg>
        <pc:spChg chg="add mod">
          <ac:chgData name="Manirujjaman, Md." userId="71830597-1daa-4b00-a396-8c0b49de16a4" providerId="ADAL" clId="{11852027-B5BD-488B-81C4-BC06A6EE44F8}" dt="2026-05-26T22:40:23.398" v="86" actId="1076"/>
          <ac:spMkLst>
            <pc:docMk/>
            <pc:sldMk cId="3551134013" sldId="256"/>
            <ac:spMk id="8" creationId="{529C4580-DE3D-C2A0-5D5C-D45DAEABDBE1}"/>
          </ac:spMkLst>
        </pc:spChg>
        <pc:picChg chg="add mod">
          <ac:chgData name="Manirujjaman, Md." userId="71830597-1daa-4b00-a396-8c0b49de16a4" providerId="ADAL" clId="{11852027-B5BD-488B-81C4-BC06A6EE44F8}" dt="2026-05-26T22:40:27.757" v="108" actId="1036"/>
          <ac:picMkLst>
            <pc:docMk/>
            <pc:sldMk cId="3551134013" sldId="256"/>
            <ac:picMk id="5" creationId="{9CDFE0F6-CE41-BF10-866C-975A675D0DDA}"/>
          </ac:picMkLst>
        </pc:picChg>
        <pc:picChg chg="add del mod">
          <ac:chgData name="Manirujjaman, Md." userId="71830597-1daa-4b00-a396-8c0b49de16a4" providerId="ADAL" clId="{11852027-B5BD-488B-81C4-BC06A6EE44F8}" dt="2026-05-26T22:07:00.888" v="9" actId="931"/>
          <ac:picMkLst>
            <pc:docMk/>
            <pc:sldMk cId="3551134013" sldId="256"/>
            <ac:picMk id="7" creationId="{2F575416-4388-60AC-6FA9-FFF7C9836A6B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175B47-6D5A-4F7D-DF2D-FD8E38CC5A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CAC889-1AF8-B8C0-3B9C-2905FFE8712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680A5-4934-4778-D0BD-F0039D04E7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7DDA26-BE3E-4397-0597-F06628E19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6CE15F-DC78-0B5B-E091-7C3AB467B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429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C68C7-304C-7692-9EFA-3C15943288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203EAA-FCF1-E816-1CBD-4EA403C711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710819-42F2-A729-3FCA-E84002AD9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A8A795-8E19-FC9E-972E-4A77B4455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E4EF-4641-8C72-BECE-2C544004B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288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7333519-08A0-0E83-BF21-1563BC5F1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7D91F4-A780-D787-080E-807E801673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77D4F-AA3D-F073-D6FF-104493B6F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ACF23F-812B-DB73-4D9C-5923823DD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8FC7ED-11D0-5396-C898-8D64ACAB6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72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CD31D2-7F87-0BA1-6C6F-9014E1285B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5A8333-1C29-024D-BBC7-D9AA12935C7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E83C8A-80B2-B181-0938-A2DAD3B7A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9DDCDA-3D30-AA5B-C4EE-67B25ADD99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51CEDC-DC62-72E5-E252-94D2D1615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2259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C46E3-74CC-7A62-2F06-003177BEF3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853540-2568-7AE6-15B1-AFFDDA83B5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72366C-0181-C76F-AC37-B01DFD1463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10ADC-B520-D166-410A-A6F216643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4E05E-B875-182C-CC67-B9D82693F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8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339B6-A531-7727-B8A6-A0342ACEB8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C0F6E1-DC6F-E503-510B-B30F958AC4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1699C1-327C-3220-60B4-825369FF85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670B75-1FA5-3A41-1371-7CF417603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199B4E-81F5-CDB7-79EE-C77090D3C7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00E610-AE5F-DCAE-A23C-7AFA9FA8D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0993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9600A-D4C2-0EE0-7618-E51A875CB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7BEA17-1EDF-9C1F-59DE-3850F6B3BC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390299-DBCB-B642-EE6E-B07C1ADF8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B47541-0E63-5974-01DF-607FAC22EA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6DF9674-1129-56BA-D6B5-FAB7DA6BCD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4B5A65-C373-2CBB-F957-4DADD0A10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FB128C-D74E-1A77-1F78-8ECF23CE0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230CB7-4A3F-AB35-589E-08BE7D6F5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3485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17308A-D322-194F-A091-602FF7E6F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A7A6BC-5B41-2279-0666-398EEF75AD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A21731D-D115-F808-77B1-19343FE4B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5DAAB2-49C6-C017-24D2-01F59A520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4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3D0BF2-FFF0-7CD4-340D-5EDDE8D3E3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49C4DC-44F5-5A3E-05A1-A56844481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DF8C3A-E8C6-08A1-B41D-31571C24A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5873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A2C35-F50D-76B5-D1E7-8E290BCDA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D4747B-5FC8-CA94-9B68-3DC8F88474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AA004A1-3C73-6674-7EF0-908B43F99E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66742D-AEE7-1B69-E6BB-8BB4A190A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8FD837-A95B-EBE4-662E-E97E3AF98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AF0D30-FD79-63F3-2350-7BEFE01E6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317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D68BC8-EC58-9707-760D-A294B16FC9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3D26656-E30B-18B9-12E4-3DDCD675B2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FA85F7-25BF-BD5C-6145-132B9E2000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4FD349-0E67-66E8-7523-EF2EDF209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41A564-7C6D-9943-9D92-FDD89DA3A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B5D32-00E9-030D-06EC-DEBB531314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847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0FC1A6-D6A3-CF40-777F-DA0B8A7975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0405A5F-8607-9D2C-5EF2-1A0C7B64E9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5149B-F954-D787-C7C0-95D858311B3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070DA19-2AF9-41D2-B39F-E75FA3226BEF}" type="datetimeFigureOut">
              <a:rPr lang="en-US" smtClean="0"/>
              <a:t>6/2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3F6701-2363-C25E-D28C-65C589BB68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A0C7B0-7C6E-7CB8-1C3C-1C908B66D9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55DBFC7-9839-4239-A2F5-C394D091E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252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CDFE0F6-CE41-BF10-866C-975A675D0D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7863" y="343897"/>
            <a:ext cx="7163463" cy="542686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29C4580-DE3D-C2A0-5D5C-D45DAEABDBE1}"/>
              </a:ext>
            </a:extLst>
          </p:cNvPr>
          <p:cNvSpPr txBox="1"/>
          <p:nvPr/>
        </p:nvSpPr>
        <p:spPr>
          <a:xfrm>
            <a:off x="3039974" y="6068471"/>
            <a:ext cx="6724228" cy="2718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400"/>
              </a:lnSpc>
            </a:pP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(S2)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anoString and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NA-seq data integration between control and obese groups (n=4/group). </a:t>
            </a:r>
          </a:p>
        </p:txBody>
      </p:sp>
    </p:spTree>
    <p:extLst>
      <p:ext uri="{BB962C8B-B14F-4D97-AF65-F5344CB8AC3E}">
        <p14:creationId xmlns:p14="http://schemas.microsoft.com/office/powerpoint/2010/main" val="3551134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2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irujjaman, Md.</dc:creator>
  <cp:lastModifiedBy>MDPI</cp:lastModifiedBy>
  <cp:revision>2</cp:revision>
  <dcterms:created xsi:type="dcterms:W3CDTF">2026-05-26T22:06:29Z</dcterms:created>
  <dcterms:modified xsi:type="dcterms:W3CDTF">2026-06-02T11:42:17Z</dcterms:modified>
</cp:coreProperties>
</file>